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07" r:id="rId2"/>
    <p:sldId id="312" r:id="rId3"/>
    <p:sldId id="308" r:id="rId4"/>
    <p:sldId id="313" r:id="rId5"/>
    <p:sldId id="314" r:id="rId6"/>
    <p:sldId id="315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25" autoAdjust="0"/>
    <p:restoredTop sz="94008" autoAdjust="0"/>
  </p:normalViewPr>
  <p:slideViewPr>
    <p:cSldViewPr snapToGrid="0">
      <p:cViewPr varScale="1">
        <p:scale>
          <a:sx n="109" d="100"/>
          <a:sy n="109" d="100"/>
        </p:scale>
        <p:origin x="8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9581B-0A08-4BBF-A36F-6AE69238D1AE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C467BE-BDAD-4C8B-9933-CF412C3342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773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CCAA14-FB75-4B31-8334-1CA1278BA9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F2CAC6F-ED81-43DE-A12A-4F9BAF681B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7984CE-6FC0-4F70-9BCF-EFBF75C81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232BE6-CDB4-4BFA-903E-84922E9DD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EFDC09-D8C0-4390-87C4-5C29C1131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706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4DEB11-B195-4BF6-A68D-1BBD841C6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3A81B36-E4B6-4C85-901D-443B91EB71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AA9926-DB07-4576-BC1D-3E8812145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F4279C-4C94-4FE0-9CCC-9A0F806D6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EE282F-B795-47C1-9F16-C30C5AB05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316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11994C5-3F1D-409D-B06A-CF86E279FD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955398-EC82-40B9-AA82-7E12FC6613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0D65FD-24C4-463C-8A79-C3AA20745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25A105-426B-4C2A-80B4-2B9C52A2E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B224D5-3E4B-4124-A052-3E58E2420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73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FBFE9D-A40C-4C92-8155-8D3B804653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7B2D3F-E19C-441A-BCE7-FA769D48B0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568C0C-9129-4C2B-BAE3-3604F68DC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522FE8-90C3-4929-86F8-8B5C00BF7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75F5E8-2A46-4655-92E8-D2553DC8F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8088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41C43A-5D77-4B07-95EB-DB049AE48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F0469FF-43F1-4878-8CF4-793CD7CE1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064741-D23A-4457-9761-A834475A9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4991C4-2C95-4AD4-BB64-C83218248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B5CA42-9AD5-4FA1-9106-ED475398F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464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42EF84-E394-42DF-BCE5-288F7DDDC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F4CBDE-688F-40C2-B72F-FDAE0F9DD7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40E467-9889-40A4-8240-3EC6B8FBA0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771A91-1520-49B0-860C-CA58D6D5C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3A073A-28FE-4B47-B9CE-585F5A40C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7E0539D-8ED1-4762-A6E8-D5EC947A5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908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C2FC4F-678F-4EA0-AF31-17CC86C22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9DBD877-E650-4869-8467-6E80E941EE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AEE818-CB1C-468B-8F55-709D856173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504DF70-D9C5-4DC0-ACE4-294CBDE74B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0C048B9-712B-4B4A-8E07-D471F078E2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1541AED-92CF-43B8-92A9-AAFB6F254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8FE4309-8C71-48CA-A7D9-8F7645303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5630CB6-168D-4A88-8533-47844A97A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139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83522B-9A25-4757-AA54-A1B07C46E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062AEC-231C-4D1A-87A0-5729466E6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5CD0C92-2B28-4182-A6C7-4FF1A1B4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C0340D8-A783-488B-89A0-F34F73175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1267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30EFEFA-92B6-4EAE-A08B-7B0653787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7F51650-7C5B-498C-8BAB-670B772A8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EF1396F-9271-435D-9145-3F3A8791E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959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AAD13E-4678-462D-A8EF-0676C8553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A4780B-94E5-4B80-9DBF-7DF5DB50FB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A76397F-AF06-4399-A334-DDDB4F7C83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F187F5-67C9-4FC6-9F66-01E28B215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6808B8F-8FC9-4F5C-9F91-8BFC0625B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760F6F-0CE6-47A4-94B8-2B2574655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20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9B1C64-AF74-4D64-B52B-2B1B58245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26C3A6D-6362-44F2-BDB8-D8BE350D0C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CD0B47-5331-41EF-851C-BAEDB53C3A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B1BDD15-449A-4A00-AB5F-52B0B4CCA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542BDE-EC9B-4B86-BE56-321856AF9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6953D4-C265-4D6C-B091-6F6F57952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359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031C1F-C5B5-4B0B-BE92-5680E3C75A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D42F19E-AEDD-4666-97D2-80B17AB1B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206671-04E1-43A1-8E52-12BB6F9813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A7D35-08F8-4436-AF0E-3921BC435444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309705-4425-4FBE-B218-4A7F981C81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3CB44C-4D5B-498B-916E-9F460596CB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DA2E3-9898-4DD9-91E2-CAA6C39033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872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FE8872E4-6256-0551-7240-D9324086072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646067" y="3390192"/>
          <a:ext cx="4690850" cy="32794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500616" imgH="3146092" progId="Prism8.Document">
                  <p:embed/>
                </p:oleObj>
              </mc:Choice>
              <mc:Fallback>
                <p:oleObj name="Prism 8" r:id="rId2" imgW="4500616" imgH="3146092" progId="Prism8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FE8872E4-6256-0551-7240-D932408607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6067" y="3390192"/>
                        <a:ext cx="4690850" cy="32794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26045946-550C-00E6-A034-9A8066F8B4C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13415" y="3392307"/>
          <a:ext cx="4623092" cy="32794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424267" imgH="3138171" progId="Prism8.Document">
                  <p:embed/>
                </p:oleObj>
              </mc:Choice>
              <mc:Fallback>
                <p:oleObj name="Prism 8" r:id="rId4" imgW="4424267" imgH="3138171" progId="Prism8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26045946-550C-00E6-A034-9A8066F8B4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013415" y="3392307"/>
                        <a:ext cx="4623092" cy="32794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図 14">
            <a:extLst>
              <a:ext uri="{FF2B5EF4-FFF2-40B4-BE49-F238E27FC236}">
                <a16:creationId xmlns:a16="http://schemas.microsoft.com/office/drawing/2014/main" id="{F8748152-4B8B-5E34-D1AB-C3677DE4A6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3647" y="125846"/>
            <a:ext cx="5507235" cy="3072108"/>
          </a:xfrm>
          <a:prstGeom prst="rect">
            <a:avLst/>
          </a:prstGeom>
        </p:spPr>
      </p:pic>
      <p:sp>
        <p:nvSpPr>
          <p:cNvPr id="16" name="タイトル 1">
            <a:extLst>
              <a:ext uri="{FF2B5EF4-FFF2-40B4-BE49-F238E27FC236}">
                <a16:creationId xmlns:a16="http://schemas.microsoft.com/office/drawing/2014/main" id="{8AA85A25-6EAB-E6AB-5FF3-C6FEB57C8099}"/>
              </a:ext>
            </a:extLst>
          </p:cNvPr>
          <p:cNvSpPr txBox="1">
            <a:spLocks/>
          </p:cNvSpPr>
          <p:nvPr/>
        </p:nvSpPr>
        <p:spPr>
          <a:xfrm>
            <a:off x="82306" y="6542088"/>
            <a:ext cx="2214626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タイトル 1">
            <a:extLst>
              <a:ext uri="{FF2B5EF4-FFF2-40B4-BE49-F238E27FC236}">
                <a16:creationId xmlns:a16="http://schemas.microsoft.com/office/drawing/2014/main" id="{C8AAA774-15AC-F8C2-22DB-A02740BF9CB7}"/>
              </a:ext>
            </a:extLst>
          </p:cNvPr>
          <p:cNvSpPr txBox="1">
            <a:spLocks/>
          </p:cNvSpPr>
          <p:nvPr/>
        </p:nvSpPr>
        <p:spPr>
          <a:xfrm>
            <a:off x="1224019" y="3243265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タイトル 1">
            <a:extLst>
              <a:ext uri="{FF2B5EF4-FFF2-40B4-BE49-F238E27FC236}">
                <a16:creationId xmlns:a16="http://schemas.microsoft.com/office/drawing/2014/main" id="{C42914F4-B6A6-3D22-78FF-8C13791FB783}"/>
              </a:ext>
            </a:extLst>
          </p:cNvPr>
          <p:cNvSpPr txBox="1">
            <a:spLocks/>
          </p:cNvSpPr>
          <p:nvPr/>
        </p:nvSpPr>
        <p:spPr>
          <a:xfrm>
            <a:off x="6613531" y="3262738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タイトル 1">
            <a:extLst>
              <a:ext uri="{FF2B5EF4-FFF2-40B4-BE49-F238E27FC236}">
                <a16:creationId xmlns:a16="http://schemas.microsoft.com/office/drawing/2014/main" id="{4E908B31-0F24-D76D-1779-BB93026B3DB4}"/>
              </a:ext>
            </a:extLst>
          </p:cNvPr>
          <p:cNvSpPr txBox="1">
            <a:spLocks/>
          </p:cNvSpPr>
          <p:nvPr/>
        </p:nvSpPr>
        <p:spPr>
          <a:xfrm>
            <a:off x="3313225" y="30394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コンテンツ プレースホルダー 2">
            <a:extLst>
              <a:ext uri="{FF2B5EF4-FFF2-40B4-BE49-F238E27FC236}">
                <a16:creationId xmlns:a16="http://schemas.microsoft.com/office/drawing/2014/main" id="{F803DE1E-7386-8534-EF25-A01B4AB51A4B}"/>
              </a:ext>
            </a:extLst>
          </p:cNvPr>
          <p:cNvSpPr txBox="1">
            <a:spLocks/>
          </p:cNvSpPr>
          <p:nvPr/>
        </p:nvSpPr>
        <p:spPr>
          <a:xfrm>
            <a:off x="3138959" y="4532397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8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コンテンツ プレースホルダー 2">
            <a:extLst>
              <a:ext uri="{FF2B5EF4-FFF2-40B4-BE49-F238E27FC236}">
                <a16:creationId xmlns:a16="http://schemas.microsoft.com/office/drawing/2014/main" id="{B5FADB90-283D-BFE5-5D68-FFC5423E6970}"/>
              </a:ext>
            </a:extLst>
          </p:cNvPr>
          <p:cNvSpPr txBox="1">
            <a:spLocks/>
          </p:cNvSpPr>
          <p:nvPr/>
        </p:nvSpPr>
        <p:spPr>
          <a:xfrm>
            <a:off x="1601739" y="4446397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8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コンテンツ プレースホルダー 2">
            <a:extLst>
              <a:ext uri="{FF2B5EF4-FFF2-40B4-BE49-F238E27FC236}">
                <a16:creationId xmlns:a16="http://schemas.microsoft.com/office/drawing/2014/main" id="{127A9655-C424-05C8-57A6-B63BB7572EE3}"/>
              </a:ext>
            </a:extLst>
          </p:cNvPr>
          <p:cNvSpPr txBox="1">
            <a:spLocks/>
          </p:cNvSpPr>
          <p:nvPr/>
        </p:nvSpPr>
        <p:spPr>
          <a:xfrm>
            <a:off x="2750042" y="5373010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.1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2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コンテンツ プレースホルダー 2">
            <a:extLst>
              <a:ext uri="{FF2B5EF4-FFF2-40B4-BE49-F238E27FC236}">
                <a16:creationId xmlns:a16="http://schemas.microsoft.com/office/drawing/2014/main" id="{52409B03-C2E5-76A9-889B-D41142EE2EC1}"/>
              </a:ext>
            </a:extLst>
          </p:cNvPr>
          <p:cNvSpPr txBox="1">
            <a:spLocks/>
          </p:cNvSpPr>
          <p:nvPr/>
        </p:nvSpPr>
        <p:spPr>
          <a:xfrm>
            <a:off x="2395093" y="4355940"/>
            <a:ext cx="1148303" cy="33282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.3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3 patient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コンテンツ プレースホルダー 2">
            <a:extLst>
              <a:ext uri="{FF2B5EF4-FFF2-40B4-BE49-F238E27FC236}">
                <a16:creationId xmlns:a16="http://schemas.microsoft.com/office/drawing/2014/main" id="{F03E3D73-B5DB-6927-FC93-7DB31A7E8561}"/>
              </a:ext>
            </a:extLst>
          </p:cNvPr>
          <p:cNvSpPr txBox="1">
            <a:spLocks/>
          </p:cNvSpPr>
          <p:nvPr/>
        </p:nvSpPr>
        <p:spPr>
          <a:xfrm>
            <a:off x="4873807" y="1391263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.6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8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コンテンツ プレースホルダー 2">
            <a:extLst>
              <a:ext uri="{FF2B5EF4-FFF2-40B4-BE49-F238E27FC236}">
                <a16:creationId xmlns:a16="http://schemas.microsoft.com/office/drawing/2014/main" id="{C5D9D0A9-CC3A-6326-2149-F6D4D8D035DC}"/>
              </a:ext>
            </a:extLst>
          </p:cNvPr>
          <p:cNvSpPr txBox="1">
            <a:spLocks/>
          </p:cNvSpPr>
          <p:nvPr/>
        </p:nvSpPr>
        <p:spPr>
          <a:xfrm>
            <a:off x="5780276" y="1704965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.5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9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コンテンツ プレースホルダー 2">
            <a:extLst>
              <a:ext uri="{FF2B5EF4-FFF2-40B4-BE49-F238E27FC236}">
                <a16:creationId xmlns:a16="http://schemas.microsoft.com/office/drawing/2014/main" id="{75775A34-1C64-3A1C-D21C-F732A2314602}"/>
              </a:ext>
            </a:extLst>
          </p:cNvPr>
          <p:cNvSpPr txBox="1">
            <a:spLocks/>
          </p:cNvSpPr>
          <p:nvPr/>
        </p:nvSpPr>
        <p:spPr>
          <a:xfrm>
            <a:off x="5225175" y="870837"/>
            <a:ext cx="1148303" cy="33282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.9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 patie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コンテンツ プレースホルダー 2">
            <a:extLst>
              <a:ext uri="{FF2B5EF4-FFF2-40B4-BE49-F238E27FC236}">
                <a16:creationId xmlns:a16="http://schemas.microsoft.com/office/drawing/2014/main" id="{29347B80-AAFC-5247-4217-76C606906899}"/>
              </a:ext>
            </a:extLst>
          </p:cNvPr>
          <p:cNvSpPr txBox="1">
            <a:spLocks/>
          </p:cNvSpPr>
          <p:nvPr/>
        </p:nvSpPr>
        <p:spPr>
          <a:xfrm>
            <a:off x="7563864" y="4721657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.5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コンテンツ プレースホルダー 2">
            <a:extLst>
              <a:ext uri="{FF2B5EF4-FFF2-40B4-BE49-F238E27FC236}">
                <a16:creationId xmlns:a16="http://schemas.microsoft.com/office/drawing/2014/main" id="{5400404D-4AA3-7F0F-AC3A-7B1744C6E816}"/>
              </a:ext>
            </a:extLst>
          </p:cNvPr>
          <p:cNvSpPr txBox="1">
            <a:spLocks/>
          </p:cNvSpPr>
          <p:nvPr/>
        </p:nvSpPr>
        <p:spPr>
          <a:xfrm>
            <a:off x="8479858" y="5173386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.5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1707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4A1610-2D8B-3030-41F7-E8C88BA7BB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36E1E18-5CD6-9F7F-6AC0-8F3E6A8598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iveness of H1 antihistamines depending on how to review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Number of patients with efficacy determined by MUD-based or interview-based.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atients with MUD-based group were selected and analyzed. 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patients with interview-based group were selected and analyzed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7955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4B167DBD-4970-9EF8-0B6E-1B0DF24105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3148758"/>
              </p:ext>
            </p:extLst>
          </p:nvPr>
        </p:nvGraphicFramePr>
        <p:xfrm>
          <a:off x="3716114" y="200708"/>
          <a:ext cx="5696393" cy="31290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360260" imgH="2944826" progId="Prism8.Document">
                  <p:embed/>
                </p:oleObj>
              </mc:Choice>
              <mc:Fallback>
                <p:oleObj name="Prism 8" r:id="rId2" imgW="5360260" imgH="2944826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4B167DBD-4970-9EF8-0B6E-1B0DF24105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114" y="200708"/>
                        <a:ext cx="5696393" cy="31290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タイトル 1">
            <a:extLst>
              <a:ext uri="{FF2B5EF4-FFF2-40B4-BE49-F238E27FC236}">
                <a16:creationId xmlns:a16="http://schemas.microsoft.com/office/drawing/2014/main" id="{2454EEA2-F560-2B72-0576-1929304A493B}"/>
              </a:ext>
            </a:extLst>
          </p:cNvPr>
          <p:cNvSpPr txBox="1">
            <a:spLocks/>
          </p:cNvSpPr>
          <p:nvPr/>
        </p:nvSpPr>
        <p:spPr>
          <a:xfrm>
            <a:off x="82306" y="6542088"/>
            <a:ext cx="2214626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9E242D8B-47B0-873C-4FFD-9D7D1D8EE6A0}"/>
              </a:ext>
            </a:extLst>
          </p:cNvPr>
          <p:cNvSpPr txBox="1">
            <a:spLocks/>
          </p:cNvSpPr>
          <p:nvPr/>
        </p:nvSpPr>
        <p:spPr>
          <a:xfrm>
            <a:off x="159308" y="3319691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629EEF48-AA4E-2953-CAD2-AE423CC9D0C6}"/>
              </a:ext>
            </a:extLst>
          </p:cNvPr>
          <p:cNvSpPr txBox="1">
            <a:spLocks/>
          </p:cNvSpPr>
          <p:nvPr/>
        </p:nvSpPr>
        <p:spPr>
          <a:xfrm>
            <a:off x="6288759" y="3319691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タイトル 1">
            <a:extLst>
              <a:ext uri="{FF2B5EF4-FFF2-40B4-BE49-F238E27FC236}">
                <a16:creationId xmlns:a16="http://schemas.microsoft.com/office/drawing/2014/main" id="{DB6C0D42-12F7-97F9-900E-BCC6686AB162}"/>
              </a:ext>
            </a:extLst>
          </p:cNvPr>
          <p:cNvSpPr txBox="1">
            <a:spLocks/>
          </p:cNvSpPr>
          <p:nvPr/>
        </p:nvSpPr>
        <p:spPr>
          <a:xfrm>
            <a:off x="3600384" y="42752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コンテンツ プレースホルダー 2">
            <a:extLst>
              <a:ext uri="{FF2B5EF4-FFF2-40B4-BE49-F238E27FC236}">
                <a16:creationId xmlns:a16="http://schemas.microsoft.com/office/drawing/2014/main" id="{B6CC1A3A-5337-3A17-62C8-97A12CE526A3}"/>
              </a:ext>
            </a:extLst>
          </p:cNvPr>
          <p:cNvSpPr txBox="1">
            <a:spLocks/>
          </p:cNvSpPr>
          <p:nvPr/>
        </p:nvSpPr>
        <p:spPr>
          <a:xfrm>
            <a:off x="4947697" y="1156441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4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コンテンツ プレースホルダー 2">
            <a:extLst>
              <a:ext uri="{FF2B5EF4-FFF2-40B4-BE49-F238E27FC236}">
                <a16:creationId xmlns:a16="http://schemas.microsoft.com/office/drawing/2014/main" id="{188EDDB2-30C2-2CDB-2182-87708934D212}"/>
              </a:ext>
            </a:extLst>
          </p:cNvPr>
          <p:cNvSpPr txBox="1">
            <a:spLocks/>
          </p:cNvSpPr>
          <p:nvPr/>
        </p:nvSpPr>
        <p:spPr>
          <a:xfrm>
            <a:off x="5416007" y="1995474"/>
            <a:ext cx="1148303" cy="32125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3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.6%</a:t>
            </a:r>
          </a:p>
          <a:p>
            <a:pPr marL="0" indent="0" algn="ctr">
              <a:lnSpc>
                <a:spcPct val="10000"/>
              </a:lnSpc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1 patient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B0B8F24B-DD9E-2F9E-F5CB-AFE82E0CB72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03110" y="3465828"/>
          <a:ext cx="5545494" cy="3122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5212604" imgH="2935464" progId="Prism8.Document">
                  <p:embed/>
                </p:oleObj>
              </mc:Choice>
              <mc:Fallback>
                <p:oleObj name="Prism 8" r:id="rId4" imgW="5212604" imgH="2935464" progId="Prism8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B0B8F24B-DD9E-2F9E-F5CB-AFE82E0CB72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03110" y="3465828"/>
                        <a:ext cx="5545494" cy="3122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38990C0C-8B35-E832-2F53-D387FD797D9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7748" y="3465829"/>
          <a:ext cx="5545494" cy="3122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5212604" imgH="2935464" progId="Prism8.Document">
                  <p:embed/>
                </p:oleObj>
              </mc:Choice>
              <mc:Fallback>
                <p:oleObj name="Prism 8" r:id="rId6" imgW="5212604" imgH="2935464" progId="Prism8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38990C0C-8B35-E832-2F53-D387FD797D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7748" y="3465829"/>
                        <a:ext cx="5545494" cy="3122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528540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4A1610-2D8B-3030-41F7-E8C88BA7BB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36E1E18-5CD6-9F7F-6AC0-8F3E6A8598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iveness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dening therapy depending on how to review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Number of patients with efficacy determined by MUD-based or interview-based.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The patients with MUD-based group were selected and analyzed. (C) The patients with interview-based group were selected and analyzed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72970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9DA92BD-B609-F59B-61A1-F3DAA3FA37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28449"/>
          <a:stretch/>
        </p:blipFill>
        <p:spPr>
          <a:xfrm>
            <a:off x="3073109" y="374802"/>
            <a:ext cx="2680591" cy="271054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E05C3D90-09FE-46C0-D9A3-198DCC88B9D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81" r="5749" b="9950"/>
          <a:stretch/>
        </p:blipFill>
        <p:spPr>
          <a:xfrm>
            <a:off x="6537903" y="374801"/>
            <a:ext cx="2680591" cy="2710543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4FAD75C-311F-34D2-3F6E-224B954D0AF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61" t="14574" r="23487" b="7546"/>
          <a:stretch/>
        </p:blipFill>
        <p:spPr>
          <a:xfrm>
            <a:off x="3073109" y="3952820"/>
            <a:ext cx="2680592" cy="2589268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802E698-7055-B7AA-9EEA-E2DEADFD554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14" t="21918" r="30419" b="10959"/>
          <a:stretch/>
        </p:blipFill>
        <p:spPr>
          <a:xfrm>
            <a:off x="6537904" y="3952820"/>
            <a:ext cx="2680590" cy="2500755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184F8C9F-DAE9-96CA-0DA1-E5E7A0677B8D}"/>
              </a:ext>
            </a:extLst>
          </p:cNvPr>
          <p:cNvSpPr txBox="1">
            <a:spLocks/>
          </p:cNvSpPr>
          <p:nvPr/>
        </p:nvSpPr>
        <p:spPr>
          <a:xfrm>
            <a:off x="82306" y="6542088"/>
            <a:ext cx="2214626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5F49561C-B55B-6B0A-1CAB-87A878FBCA24}"/>
              </a:ext>
            </a:extLst>
          </p:cNvPr>
          <p:cNvSpPr txBox="1">
            <a:spLocks/>
          </p:cNvSpPr>
          <p:nvPr/>
        </p:nvSpPr>
        <p:spPr>
          <a:xfrm>
            <a:off x="6197030" y="141022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タイトル 1">
            <a:extLst>
              <a:ext uri="{FF2B5EF4-FFF2-40B4-BE49-F238E27FC236}">
                <a16:creationId xmlns:a16="http://schemas.microsoft.com/office/drawing/2014/main" id="{9B3AAC74-4E77-CD9B-DFDA-115588DDBF55}"/>
              </a:ext>
            </a:extLst>
          </p:cNvPr>
          <p:cNvSpPr txBox="1">
            <a:spLocks/>
          </p:cNvSpPr>
          <p:nvPr/>
        </p:nvSpPr>
        <p:spPr>
          <a:xfrm>
            <a:off x="2711273" y="3673590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タイトル 1">
            <a:extLst>
              <a:ext uri="{FF2B5EF4-FFF2-40B4-BE49-F238E27FC236}">
                <a16:creationId xmlns:a16="http://schemas.microsoft.com/office/drawing/2014/main" id="{E9C730CB-DAAB-B176-00F9-72614B40C81C}"/>
              </a:ext>
            </a:extLst>
          </p:cNvPr>
          <p:cNvSpPr txBox="1">
            <a:spLocks/>
          </p:cNvSpPr>
          <p:nvPr/>
        </p:nvSpPr>
        <p:spPr>
          <a:xfrm>
            <a:off x="2711273" y="141022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タイトル 1">
            <a:extLst>
              <a:ext uri="{FF2B5EF4-FFF2-40B4-BE49-F238E27FC236}">
                <a16:creationId xmlns:a16="http://schemas.microsoft.com/office/drawing/2014/main" id="{73AC7A09-0E77-645E-D204-225F0A3549A0}"/>
              </a:ext>
            </a:extLst>
          </p:cNvPr>
          <p:cNvSpPr txBox="1">
            <a:spLocks/>
          </p:cNvSpPr>
          <p:nvPr/>
        </p:nvSpPr>
        <p:spPr>
          <a:xfrm>
            <a:off x="6197030" y="3636908"/>
            <a:ext cx="799769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64696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4A1610-2D8B-3030-41F7-E8C88BA7BB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36E1E18-5CD6-9F7F-6AC0-8F3E6A8598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</a:t>
            </a:r>
          </a:p>
          <a:p>
            <a:pPr marL="0" indent="0">
              <a:buNone/>
            </a:pP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measuring the change of MUD after treatment. One case;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mation of wheal was found with VL irradiation before treatment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lin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ction with same dose of VL irradiation was diminished after induction of H1 antihistamine treatment.</a:t>
            </a:r>
          </a:p>
          <a:p>
            <a:pPr marL="0" indent="0">
              <a:buNone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nother case; (C) Comparison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lin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ction with VL irradiation before H1 antihistamine treatment, and (D) after H1 antihistamine treatment.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5511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17</TotalTime>
  <Words>281</Words>
  <Application>Microsoft Office PowerPoint</Application>
  <PresentationFormat>ワイド画面</PresentationFormat>
  <Paragraphs>49</Paragraphs>
  <Slides>6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游ゴシック Light</vt:lpstr>
      <vt:lpstr>Arial</vt:lpstr>
      <vt:lpstr>Times New Roman</vt:lpstr>
      <vt:lpstr>Office テーマ</vt:lpstr>
      <vt:lpstr>Prism 8</vt:lpstr>
      <vt:lpstr>PowerPoint プレゼンテーション</vt:lpstr>
      <vt:lpstr>Figure Legends</vt:lpstr>
      <vt:lpstr>PowerPoint プレゼンテーション</vt:lpstr>
      <vt:lpstr>Figure Legends</vt:lpstr>
      <vt:lpstr>PowerPoint プレゼンテーション</vt:lpstr>
      <vt:lpstr>Figure Legend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mamura Shinya</dc:creator>
  <cp:lastModifiedBy>今村真也</cp:lastModifiedBy>
  <cp:revision>141</cp:revision>
  <dcterms:created xsi:type="dcterms:W3CDTF">2021-04-10T11:56:34Z</dcterms:created>
  <dcterms:modified xsi:type="dcterms:W3CDTF">2024-01-22T14:13:37Z</dcterms:modified>
</cp:coreProperties>
</file>